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9B4BED-6D72-4B75-AED7-7976CC6768A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55AEF4-9B99-43A6-85DB-FB24163A36E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2211DD-15CF-48F1-BA1A-75B7AE37E8B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788E11-1E18-4962-94C6-E6EC6BBCF66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EDF87E-B617-4C29-BC72-D15B26FE2FA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3728F5-0CC9-4189-AFFB-A84B4C4B87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81743B-5127-4795-ACBA-2520F146C7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DE39F8-D4F1-464F-B4CD-961028BD64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409D08-D7C6-4FE2-AB32-A835C6F7C1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958DDB-3811-45A5-BB1A-EC403DD0CD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FBEA2D-C91B-4450-9319-B2CE4246F5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82B0D8-0077-4EEC-9C0A-8007478D70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8269073-6AF8-4D76-A5D6-1306A30A9A63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グループ化 2"/>
          <p:cNvGrpSpPr/>
          <p:nvPr/>
        </p:nvGrpSpPr>
        <p:grpSpPr>
          <a:xfrm>
            <a:off x="549360" y="876240"/>
            <a:ext cx="5911920" cy="5898240"/>
            <a:chOff x="549360" y="876240"/>
            <a:chExt cx="5911920" cy="5898240"/>
          </a:xfrm>
        </p:grpSpPr>
        <p:sp>
          <p:nvSpPr>
            <p:cNvPr id="42" name="テキスト ボックス 7170"/>
            <p:cNvSpPr/>
            <p:nvPr/>
          </p:nvSpPr>
          <p:spPr>
            <a:xfrm>
              <a:off x="549360" y="876240"/>
              <a:ext cx="2375280" cy="587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CTnPg1 family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CTnPi1-a in OMA1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attT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attL         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attR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CTnPi4 in strain 1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attT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attL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attR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onsensus sequence of the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att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core sequences of CTnPg1 family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TnPi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attT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CTnPi2-a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 attL 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CTnPi2-b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 attL 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CTnPi2-a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 attR 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CTnPi2-b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 attR 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att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core sequenc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TnPi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attT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CTnPi3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 attL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CTnPi3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 attR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att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core sequenc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テキスト ボックス 67"/>
            <p:cNvSpPr/>
            <p:nvPr/>
          </p:nvSpPr>
          <p:spPr>
            <a:xfrm>
              <a:off x="2241720" y="1185480"/>
              <a:ext cx="4219560" cy="558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ACCTTGGGGATAGA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TTTTC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A 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AAAA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TCTATCATTTAGG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         </a:t>
              </a: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hI 355072              35560                     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AAAAACCTATATAC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TTTTC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ACAT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AAAA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TCTATCATTTAGG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	</a:t>
              </a: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hI 302953             302941                     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ACCTTGAGGATAGA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TTTTC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TGAG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AAAA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CCTATATACTTTT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ACCTTGAGGATAGA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TTTT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T A CT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AAAA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TCTATCATTTANG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    </a:t>
              </a: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hI 845085             845073                    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AAAACGATAGTAC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TTTT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T ACCT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AAAA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TCTATCATTTAGG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         </a:t>
              </a: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hI 786453             786441                    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ACCTTGAGGATAGA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TTTT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T ATCT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AAAA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CGATAGTACTTTT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  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TTTTC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NNNN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AAA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TGAAGCCTATTAGC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GGAGAGAGAGG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TTTGTGAACCAAA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        </a:t>
              </a: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hII 293340      293350                                       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GATAAAGAAACTAT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GGAGAGAGAGG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TTTGTGAACCAAA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</a:t>
              </a: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hII 591390      591400                   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ACACCCTTGTTTGC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GGAGAGAGAGG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TTTGTGAACCAAA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</a:t>
              </a: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hII 353041      353051                    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TGAAGCCTATTAGC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GGAGAGAGAGG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CTTTTGAACTTTTG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</a:t>
              </a: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hII 531689      531699                    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TGAAGCCTATTAGC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GGAGAGAGAGG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GATTCGAACCCCCG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1199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  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GGAGAGAGAGG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TCAGAGTATTTAAA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GCGGTGCGTACGA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AACTTGAACTTGT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         </a:t>
              </a: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hI 454604         454616                                       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GTTTAGGATTTTTT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GCGGTGCGTACGA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AACTTGAACTTGT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    </a:t>
              </a: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hI 537279         537291                                       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TCAGAGTATTTAAA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GCGGTGCGTACGA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GACTCGAACTCGTG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  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GCGGTGCGTACG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テキスト ボックス 7171"/>
            <p:cNvSpPr/>
            <p:nvPr/>
          </p:nvSpPr>
          <p:spPr>
            <a:xfrm>
              <a:off x="3839400" y="1146960"/>
              <a:ext cx="485640" cy="347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9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AC 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9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TG G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テキスト ボックス 76"/>
            <p:cNvSpPr/>
            <p:nvPr/>
          </p:nvSpPr>
          <p:spPr>
            <a:xfrm>
              <a:off x="3919680" y="2177640"/>
              <a:ext cx="257040" cy="347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9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9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6" name="テキスト ボックス 8"/>
          <p:cNvSpPr/>
          <p:nvPr/>
        </p:nvSpPr>
        <p:spPr>
          <a:xfrm>
            <a:off x="529920" y="334800"/>
            <a:ext cx="1957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ry Figure  S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テキスト ボックス 1"/>
          <p:cNvSpPr/>
          <p:nvPr/>
        </p:nvSpPr>
        <p:spPr>
          <a:xfrm>
            <a:off x="623160" y="581040"/>
            <a:ext cx="264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グループ化 1"/>
          <p:cNvGrpSpPr/>
          <p:nvPr/>
        </p:nvGrpSpPr>
        <p:grpSpPr>
          <a:xfrm>
            <a:off x="890640" y="596880"/>
            <a:ext cx="5634000" cy="8712360"/>
            <a:chOff x="890640" y="596880"/>
            <a:chExt cx="5634000" cy="8712360"/>
          </a:xfrm>
        </p:grpSpPr>
        <p:pic>
          <p:nvPicPr>
            <p:cNvPr id="49" name="テキスト ボックス 7170" descr=""/>
            <p:cNvPicPr/>
            <p:nvPr/>
          </p:nvPicPr>
          <p:blipFill>
            <a:blip r:embed="rId1"/>
            <a:stretch/>
          </p:blipFill>
          <p:spPr>
            <a:xfrm>
              <a:off x="890640" y="596880"/>
              <a:ext cx="1493280" cy="8553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テキスト ボックス 67"/>
            <p:cNvSpPr/>
            <p:nvPr/>
          </p:nvSpPr>
          <p:spPr>
            <a:xfrm>
              <a:off x="2304000" y="660960"/>
              <a:ext cx="4220640" cy="864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TTTTCTGTGATTAG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TTAC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AA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GATAATCATCAAA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        </a:t>
              </a: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hI 241445           241455                                                            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TAAAAGCGGCTGTT TTAC CGTCC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AA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GATAATCATCAAA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   </a:t>
              </a: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hI 2099078         2099068                                       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AAAAGCGGCTGTT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TTAC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ACGGT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AA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GATAATCATCAAA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   </a:t>
              </a: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hI 259760           259770                                       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TTTTCTGTGATTAG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TTAC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ACGGT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AA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AAGCGGCTCTTTT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   </a:t>
              </a: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hI 2080763         2080753                                       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TTTTCTGTGATTAG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TTAC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ACGGT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AA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AAGTGTAGGTTTTG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  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TTAC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NNNNN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A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TTTTCAAGGATTAG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TTGC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AA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GATAATTCTTAAA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         </a:t>
              </a: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hI 767242          767252                                                             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TAAAACCTATTGTT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TTGC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ATTCC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AA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GATAATTCTTAAA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         </a:t>
              </a: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hI 1405588        1405578                                       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TAAAACCTATTGTT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TTGC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AGTGC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AA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GATAATTCTTAAA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</a:t>
              </a: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hII 386331          386341                                       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AAAAGCGTAGGTT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TTGC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AGTGC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AA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GATAATTCTTAAAA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</a:t>
              </a: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hII 776303          776293                                       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AAAAGCGGCTGTT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TTGC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AGTGC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AA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GATAATTCTTAAAA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</a:t>
              </a: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hI 783788           783798                                       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TTTTCAAGGATTAG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TTGC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AGTGC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AA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AAGCGTAGGTTTTG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        </a:t>
              </a: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hI 1389042         1389032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TTTTCAAGGATTAG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TTGC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GTTCC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AA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AAGCGGCTGTTTTA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</a:t>
              </a: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hII 402877          402887                                       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TTTTCAAGGATTAG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TTGC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ACGGT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AA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AAGCGGCTGTTTTG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</a:t>
              </a: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hII 759757          759747                                      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TTTTCAAGGATTAG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TTGC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ACGGT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AA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AAGCGTAGGTTTTG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  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TTGC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NNNNN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A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TTTTCAGTGATTAG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TTAC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AA GATAATTCTTAAA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         </a:t>
              </a: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hI 990673          990683                                       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TAAGAAATATTTAC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TTAC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ACACG AA GATAATTCTTAAA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         </a:t>
              </a: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hI 189199         1689189                                       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TAAAAGCGTAGGTT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TTAC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ATTGT AA GATAATTCTTAAAA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 </a:t>
              </a: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hI 1711687       1711697                                       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AAAACCTATTGTT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TTAC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ATTGT AA GATAATTCTTAAA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          </a:t>
              </a: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hI 1009094       1009104                                       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TTTTCAGTGATTAG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TTAC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ACACG AG GAAATTATTATTTA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</a:t>
              </a: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hI 1670778       1670768                                       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TTTTCAGTGATTAG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TTAC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ACACG GA AAGTGTAGGTTTTG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</a:t>
              </a: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hI 1730108       1730118                                       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TTTTCAGTGATTAG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TTAC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ACGGT AA AAGCGGCTGTTTTG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  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TTAC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NNNNN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ACGGCATTGTACT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GGGTCTGGGTAC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TACAAATCCCTTG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        </a:t>
              </a: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hI 1345665       1345654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CCGGTTCGATCCC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GGGTCTGGGTAC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TACAAATCCCTTG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5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        </a:t>
              </a:r>
              <a:r>
                <a:rPr b="0" lang="en-US" sz="6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hI 1333276       1333265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ACGGCATTGTACT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GGGTCTGGGTAC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ACAATGCCACTTG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              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Osaka"/>
                </a:rPr>
                <a:t>GGGTCTGGGTA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テキスト ボックス 7171"/>
            <p:cNvSpPr/>
            <p:nvPr/>
          </p:nvSpPr>
          <p:spPr>
            <a:xfrm>
              <a:off x="3866040" y="726120"/>
              <a:ext cx="561600" cy="347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9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ACGG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9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CGTC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テキスト ボックス 7171"/>
            <p:cNvSpPr/>
            <p:nvPr/>
          </p:nvSpPr>
          <p:spPr>
            <a:xfrm>
              <a:off x="3836520" y="2665800"/>
              <a:ext cx="561600" cy="474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9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AGTG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9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GCGC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9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T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テキスト ボックス 7171"/>
            <p:cNvSpPr/>
            <p:nvPr/>
          </p:nvSpPr>
          <p:spPr>
            <a:xfrm>
              <a:off x="4267800" y="7363800"/>
              <a:ext cx="333000" cy="347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9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A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9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GG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テキスト ボックス 7171"/>
            <p:cNvSpPr/>
            <p:nvPr/>
          </p:nvSpPr>
          <p:spPr>
            <a:xfrm>
              <a:off x="3801240" y="5529600"/>
              <a:ext cx="561600" cy="474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9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ACTG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9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GTACG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9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ourier New"/>
                  <a:ea typeface="Osaka"/>
                </a:rPr>
                <a:t>GG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5" name="テキスト ボックス 8"/>
          <p:cNvSpPr/>
          <p:nvPr/>
        </p:nvSpPr>
        <p:spPr>
          <a:xfrm>
            <a:off x="910440" y="317520"/>
            <a:ext cx="264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テキスト ボックス 8"/>
          <p:cNvSpPr/>
          <p:nvPr/>
        </p:nvSpPr>
        <p:spPr>
          <a:xfrm>
            <a:off x="852120" y="9360"/>
            <a:ext cx="1957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ry Figure  S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7-13T01:34:29Z</dcterms:created>
  <dc:creator>naito</dc:creator>
  <dc:description/>
  <dc:language>en-US</dc:language>
  <cp:lastModifiedBy>naito</cp:lastModifiedBy>
  <dcterms:modified xsi:type="dcterms:W3CDTF">2015-09-25T01:14:08Z</dcterms:modified>
  <cp:revision>2</cp:revision>
  <dc:subject/>
  <dc:title>PowerPoint プレゼンテーション</dc:title>
</cp:coreProperties>
</file>